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 varScale="1">
        <p:scale>
          <a:sx n="56" d="100"/>
          <a:sy n="56" d="100"/>
        </p:scale>
        <p:origin x="-2400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6Jun20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ack%20Up%20Shelby:Users:montagues:Documents:Baker%20Lab:MB%20Mini-Olympiad:MBScreen_Analysis_21May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054706086831"/>
          <c:y val="0.0600300331964993"/>
          <c:w val="0.87382802659913"/>
          <c:h val="0.700129440895324"/>
        </c:manualLayout>
      </c:layout>
      <c:barChart>
        <c:barDir val="col"/>
        <c:grouping val="clustered"/>
        <c:varyColors val="0"/>
        <c:ser>
          <c:idx val="0"/>
          <c:order val="0"/>
          <c:tx>
            <c:v>CIbegin</c:v>
          </c:tx>
          <c:spPr>
            <a:solidFill>
              <a:srgbClr val="FF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K$59:$K$67</c:f>
                <c:numCache>
                  <c:formatCode>General</c:formatCode>
                  <c:ptCount val="9"/>
                  <c:pt idx="0">
                    <c:v>0.0513649513563499</c:v>
                  </c:pt>
                  <c:pt idx="1">
                    <c:v>0.270993579951618</c:v>
                  </c:pt>
                  <c:pt idx="2">
                    <c:v>0.0563883144700684</c:v>
                  </c:pt>
                  <c:pt idx="4">
                    <c:v>0.0484738082709478</c:v>
                  </c:pt>
                  <c:pt idx="6">
                    <c:v>0.058016533</c:v>
                  </c:pt>
                  <c:pt idx="7">
                    <c:v>0.0364935395450113</c:v>
                  </c:pt>
                  <c:pt idx="8">
                    <c:v>0.04872858735392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59:$F$67</c:f>
              <c:strCache>
                <c:ptCount val="9"/>
                <c:pt idx="0">
                  <c:v>MB195B</c:v>
                </c:pt>
                <c:pt idx="1">
                  <c:v>MB441B</c:v>
                </c:pt>
                <c:pt idx="2">
                  <c:v>MB312B</c:v>
                </c:pt>
                <c:pt idx="4">
                  <c:v>MB315C</c:v>
                </c:pt>
                <c:pt idx="6">
                  <c:v>MB299B</c:v>
                </c:pt>
                <c:pt idx="7">
                  <c:v>MB043B</c:v>
                </c:pt>
                <c:pt idx="8">
                  <c:v>MB043C</c:v>
                </c:pt>
              </c:strCache>
            </c:strRef>
          </c:cat>
          <c:val>
            <c:numRef>
              <c:f>NewSecondaryCharts_22May15!$G$59:$G$67</c:f>
              <c:numCache>
                <c:formatCode>General</c:formatCode>
                <c:ptCount val="9"/>
                <c:pt idx="0">
                  <c:v>0.280596228070175</c:v>
                </c:pt>
                <c:pt idx="1">
                  <c:v>0.212025075757576</c:v>
                </c:pt>
                <c:pt idx="2">
                  <c:v>0.384429861111111</c:v>
                </c:pt>
                <c:pt idx="4">
                  <c:v>0.235482283950617</c:v>
                </c:pt>
                <c:pt idx="6">
                  <c:v>0.342294236</c:v>
                </c:pt>
                <c:pt idx="7">
                  <c:v>0.156910175438596</c:v>
                </c:pt>
                <c:pt idx="8">
                  <c:v>0.137796078431373</c:v>
                </c:pt>
              </c:numCache>
            </c:numRef>
          </c:val>
        </c:ser>
        <c:ser>
          <c:idx val="1"/>
          <c:order val="1"/>
          <c:tx>
            <c:v>CIend</c:v>
          </c:tx>
          <c:spPr>
            <a:solidFill>
              <a:srgbClr val="0000FF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L$59:$L$67</c:f>
                <c:numCache>
                  <c:formatCode>General</c:formatCode>
                  <c:ptCount val="9"/>
                  <c:pt idx="0">
                    <c:v>0.0116754682527746</c:v>
                  </c:pt>
                  <c:pt idx="1">
                    <c:v>0.114378238104256</c:v>
                  </c:pt>
                  <c:pt idx="2">
                    <c:v>0.0278382722994412</c:v>
                  </c:pt>
                  <c:pt idx="4">
                    <c:v>0.00744652535993541</c:v>
                  </c:pt>
                  <c:pt idx="6">
                    <c:v>0.037300838</c:v>
                  </c:pt>
                  <c:pt idx="7">
                    <c:v>0.0107919913127503</c:v>
                  </c:pt>
                  <c:pt idx="8">
                    <c:v>0.009124404991120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59:$F$67</c:f>
              <c:strCache>
                <c:ptCount val="9"/>
                <c:pt idx="0">
                  <c:v>MB195B</c:v>
                </c:pt>
                <c:pt idx="1">
                  <c:v>MB441B</c:v>
                </c:pt>
                <c:pt idx="2">
                  <c:v>MB312B</c:v>
                </c:pt>
                <c:pt idx="4">
                  <c:v>MB315C</c:v>
                </c:pt>
                <c:pt idx="6">
                  <c:v>MB299B</c:v>
                </c:pt>
                <c:pt idx="7">
                  <c:v>MB043B</c:v>
                </c:pt>
                <c:pt idx="8">
                  <c:v>MB043C</c:v>
                </c:pt>
              </c:strCache>
            </c:strRef>
          </c:cat>
          <c:val>
            <c:numRef>
              <c:f>NewSecondaryCharts_22May15!$H$59:$H$67</c:f>
              <c:numCache>
                <c:formatCode>General</c:formatCode>
                <c:ptCount val="9"/>
                <c:pt idx="0">
                  <c:v>0.0275227192982456</c:v>
                </c:pt>
                <c:pt idx="1">
                  <c:v>0.0311253787878788</c:v>
                </c:pt>
                <c:pt idx="2">
                  <c:v>0.105900729166667</c:v>
                </c:pt>
                <c:pt idx="4">
                  <c:v>0.0217346296296296</c:v>
                </c:pt>
                <c:pt idx="6">
                  <c:v>0.13007375</c:v>
                </c:pt>
                <c:pt idx="7">
                  <c:v>0.0121133333333333</c:v>
                </c:pt>
                <c:pt idx="8">
                  <c:v>0.0151566666666667</c:v>
                </c:pt>
              </c:numCache>
            </c:numRef>
          </c:val>
        </c:ser>
        <c:ser>
          <c:idx val="2"/>
          <c:order val="2"/>
          <c:tx>
            <c:v>CItest</c:v>
          </c:tx>
          <c:spPr>
            <a:solidFill>
              <a:srgbClr val="FFFF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econdaryCharts_22May15!$M$59:$M$67</c:f>
                <c:numCache>
                  <c:formatCode>General</c:formatCode>
                  <c:ptCount val="9"/>
                  <c:pt idx="0">
                    <c:v>0.0601155825142761</c:v>
                  </c:pt>
                  <c:pt idx="1">
                    <c:v>0.234553654886349</c:v>
                  </c:pt>
                  <c:pt idx="2">
                    <c:v>0.0725460189729975</c:v>
                  </c:pt>
                  <c:pt idx="4">
                    <c:v>0.0547004057819003</c:v>
                  </c:pt>
                  <c:pt idx="6">
                    <c:v>0.064610424</c:v>
                  </c:pt>
                  <c:pt idx="7">
                    <c:v>0.0687172465084609</c:v>
                  </c:pt>
                  <c:pt idx="8">
                    <c:v>0.07455207448792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econdaryCharts_22May15!$F$59:$F$67</c:f>
              <c:strCache>
                <c:ptCount val="9"/>
                <c:pt idx="0">
                  <c:v>MB195B</c:v>
                </c:pt>
                <c:pt idx="1">
                  <c:v>MB441B</c:v>
                </c:pt>
                <c:pt idx="2">
                  <c:v>MB312B</c:v>
                </c:pt>
                <c:pt idx="4">
                  <c:v>MB315C</c:v>
                </c:pt>
                <c:pt idx="6">
                  <c:v>MB299B</c:v>
                </c:pt>
                <c:pt idx="7">
                  <c:v>MB043B</c:v>
                </c:pt>
                <c:pt idx="8">
                  <c:v>MB043C</c:v>
                </c:pt>
              </c:strCache>
            </c:strRef>
          </c:cat>
          <c:val>
            <c:numRef>
              <c:f>NewSecondaryCharts_22May15!$I$59:$I$67</c:f>
              <c:numCache>
                <c:formatCode>General</c:formatCode>
                <c:ptCount val="9"/>
                <c:pt idx="0">
                  <c:v>0.221038859649123</c:v>
                </c:pt>
                <c:pt idx="1">
                  <c:v>0.137057651515152</c:v>
                </c:pt>
                <c:pt idx="2">
                  <c:v>0.5298925</c:v>
                </c:pt>
                <c:pt idx="4">
                  <c:v>0.246747716049383</c:v>
                </c:pt>
                <c:pt idx="6">
                  <c:v>0.534275833</c:v>
                </c:pt>
                <c:pt idx="7">
                  <c:v>0.189195175438596</c:v>
                </c:pt>
                <c:pt idx="8">
                  <c:v>0.2677861764705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7180856"/>
        <c:axId val="-2114209496"/>
      </c:barChart>
      <c:catAx>
        <c:axId val="-21171808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4209496"/>
        <c:crosses val="autoZero"/>
        <c:auto val="1"/>
        <c:lblAlgn val="ctr"/>
        <c:lblOffset val="100"/>
        <c:noMultiLvlLbl val="0"/>
      </c:catAx>
      <c:valAx>
        <c:axId val="-2114209496"/>
        <c:scaling>
          <c:orientation val="minMax"/>
          <c:max val="0.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1808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0975335762106622"/>
          <c:y val="0.0355522508535463"/>
          <c:w val="0.120437540347883"/>
          <c:h val="0.26394707467212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90414263843"/>
          <c:y val="0.0593228499688833"/>
          <c:w val="0.857210963196572"/>
          <c:h val="0.7217284041111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1</c:f>
              <c:strCache>
                <c:ptCount val="1"/>
                <c:pt idx="0">
                  <c:v>train begin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2:$M$19</c:f>
                <c:numCache>
                  <c:formatCode>General</c:formatCode>
                  <c:ptCount val="18"/>
                  <c:pt idx="0">
                    <c:v>0.0485851394789844</c:v>
                  </c:pt>
                  <c:pt idx="1">
                    <c:v>0.0413601864206485</c:v>
                  </c:pt>
                  <c:pt idx="2">
                    <c:v>0.0607355629363594</c:v>
                  </c:pt>
                  <c:pt idx="3">
                    <c:v>0.0642505039520255</c:v>
                  </c:pt>
                  <c:pt idx="4">
                    <c:v>0.037673991257615</c:v>
                  </c:pt>
                  <c:pt idx="5">
                    <c:v>0.0654370675897268</c:v>
                  </c:pt>
                  <c:pt idx="6">
                    <c:v>0.0600145228530439</c:v>
                  </c:pt>
                  <c:pt idx="7">
                    <c:v>0.0549366838045398</c:v>
                  </c:pt>
                  <c:pt idx="8">
                    <c:v>0.0537140860015041</c:v>
                  </c:pt>
                  <c:pt idx="9">
                    <c:v>0.0555103387853043</c:v>
                  </c:pt>
                  <c:pt idx="10">
                    <c:v>0.0458238746874767</c:v>
                  </c:pt>
                  <c:pt idx="11">
                    <c:v>0.0540684608330003</c:v>
                  </c:pt>
                  <c:pt idx="12">
                    <c:v>0.0500681862402947</c:v>
                  </c:pt>
                  <c:pt idx="13">
                    <c:v>0.0684964394742307</c:v>
                  </c:pt>
                  <c:pt idx="14">
                    <c:v>0.0720024130639644</c:v>
                  </c:pt>
                  <c:pt idx="15">
                    <c:v>0.0806129414986092</c:v>
                  </c:pt>
                  <c:pt idx="16">
                    <c:v>0.0540510079804968</c:v>
                  </c:pt>
                  <c:pt idx="17">
                    <c:v>0.05097445136492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H$2:$H$19</c:f>
              <c:strCache>
                <c:ptCount val="18"/>
                <c:pt idx="0">
                  <c:v>MB195B</c:v>
                </c:pt>
                <c:pt idx="1">
                  <c:v>MB312B</c:v>
                </c:pt>
                <c:pt idx="2">
                  <c:v>MB315C</c:v>
                </c:pt>
                <c:pt idx="3">
                  <c:v>MB299B</c:v>
                </c:pt>
                <c:pt idx="4">
                  <c:v>MB043B</c:v>
                </c:pt>
                <c:pt idx="5">
                  <c:v>MB188B</c:v>
                </c:pt>
                <c:pt idx="6">
                  <c:v>MB042B</c:v>
                </c:pt>
                <c:pt idx="7">
                  <c:v>MB040B</c:v>
                </c:pt>
                <c:pt idx="8">
                  <c:v>MB196B</c:v>
                </c:pt>
                <c:pt idx="9">
                  <c:v>MB032B</c:v>
                </c:pt>
                <c:pt idx="10">
                  <c:v>MB047B</c:v>
                </c:pt>
                <c:pt idx="11">
                  <c:v>MB316B</c:v>
                </c:pt>
                <c:pt idx="12">
                  <c:v>MB109B</c:v>
                </c:pt>
                <c:pt idx="13">
                  <c:v>MB213B</c:v>
                </c:pt>
                <c:pt idx="14">
                  <c:v>MB194B</c:v>
                </c:pt>
                <c:pt idx="15">
                  <c:v>MB087C</c:v>
                </c:pt>
                <c:pt idx="16">
                  <c:v>MB025B</c:v>
                </c:pt>
                <c:pt idx="17">
                  <c:v>MB301B</c:v>
                </c:pt>
              </c:strCache>
            </c:strRef>
          </c:cat>
          <c:val>
            <c:numRef>
              <c:f>Sheet1!$I$2:$I$19</c:f>
              <c:numCache>
                <c:formatCode>General</c:formatCode>
                <c:ptCount val="18"/>
                <c:pt idx="0">
                  <c:v>0.188404924242424</c:v>
                </c:pt>
                <c:pt idx="1">
                  <c:v>0.162604696969697</c:v>
                </c:pt>
                <c:pt idx="2">
                  <c:v>0.182913157894737</c:v>
                </c:pt>
                <c:pt idx="3">
                  <c:v>0.28924962962963</c:v>
                </c:pt>
                <c:pt idx="4">
                  <c:v>0.142324848484848</c:v>
                </c:pt>
                <c:pt idx="5">
                  <c:v>0.262106041666667</c:v>
                </c:pt>
                <c:pt idx="6">
                  <c:v>0.380740579710145</c:v>
                </c:pt>
                <c:pt idx="7">
                  <c:v>0.240453484848485</c:v>
                </c:pt>
                <c:pt idx="8">
                  <c:v>0.318366458333333</c:v>
                </c:pt>
                <c:pt idx="9">
                  <c:v>0.214195789473684</c:v>
                </c:pt>
                <c:pt idx="10">
                  <c:v>0.198603115942029</c:v>
                </c:pt>
                <c:pt idx="11">
                  <c:v>0.249319130434783</c:v>
                </c:pt>
                <c:pt idx="12">
                  <c:v>0.414885208333333</c:v>
                </c:pt>
                <c:pt idx="13">
                  <c:v>0.351205</c:v>
                </c:pt>
                <c:pt idx="14">
                  <c:v>0.407289242424242</c:v>
                </c:pt>
                <c:pt idx="15">
                  <c:v>0.288519333333333</c:v>
                </c:pt>
                <c:pt idx="16">
                  <c:v>0.463625833333333</c:v>
                </c:pt>
                <c:pt idx="17">
                  <c:v>0.431045277777778</c:v>
                </c:pt>
              </c:numCache>
            </c:numRef>
          </c:val>
        </c:ser>
        <c:ser>
          <c:idx val="1"/>
          <c:order val="1"/>
          <c:tx>
            <c:strRef>
              <c:f>Sheet1!$J$1</c:f>
              <c:strCache>
                <c:ptCount val="1"/>
                <c:pt idx="0">
                  <c:v>train end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N$2:$N$19</c:f>
                <c:numCache>
                  <c:formatCode>General</c:formatCode>
                  <c:ptCount val="18"/>
                  <c:pt idx="0">
                    <c:v>0.0129810049211281</c:v>
                  </c:pt>
                  <c:pt idx="1">
                    <c:v>0.0409195457838965</c:v>
                  </c:pt>
                  <c:pt idx="2">
                    <c:v>0.0045501401939783</c:v>
                  </c:pt>
                  <c:pt idx="3">
                    <c:v>0.029605501106011</c:v>
                  </c:pt>
                  <c:pt idx="4">
                    <c:v>0.00736154720594443</c:v>
                  </c:pt>
                  <c:pt idx="5">
                    <c:v>0.0062162193372141</c:v>
                  </c:pt>
                  <c:pt idx="6">
                    <c:v>0.0173813634225644</c:v>
                  </c:pt>
                  <c:pt idx="7">
                    <c:v>0.0121645732873368</c:v>
                  </c:pt>
                  <c:pt idx="8">
                    <c:v>0.0148002122105775</c:v>
                  </c:pt>
                  <c:pt idx="9">
                    <c:v>0.0072665493002133</c:v>
                  </c:pt>
                  <c:pt idx="10">
                    <c:v>0.052618102523339</c:v>
                  </c:pt>
                  <c:pt idx="11">
                    <c:v>0.0439470236615944</c:v>
                  </c:pt>
                  <c:pt idx="12">
                    <c:v>0.0482922701786991</c:v>
                  </c:pt>
                  <c:pt idx="13">
                    <c:v>0.0413178616160453</c:v>
                  </c:pt>
                  <c:pt idx="14">
                    <c:v>0.0360711739387658</c:v>
                  </c:pt>
                  <c:pt idx="15">
                    <c:v>0.0267709031496176</c:v>
                  </c:pt>
                  <c:pt idx="16">
                    <c:v>0.0453673582487872</c:v>
                  </c:pt>
                  <c:pt idx="17">
                    <c:v>0.05550077779821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H$2:$H$19</c:f>
              <c:strCache>
                <c:ptCount val="18"/>
                <c:pt idx="0">
                  <c:v>MB195B</c:v>
                </c:pt>
                <c:pt idx="1">
                  <c:v>MB312B</c:v>
                </c:pt>
                <c:pt idx="2">
                  <c:v>MB315C</c:v>
                </c:pt>
                <c:pt idx="3">
                  <c:v>MB299B</c:v>
                </c:pt>
                <c:pt idx="4">
                  <c:v>MB043B</c:v>
                </c:pt>
                <c:pt idx="5">
                  <c:v>MB188B</c:v>
                </c:pt>
                <c:pt idx="6">
                  <c:v>MB042B</c:v>
                </c:pt>
                <c:pt idx="7">
                  <c:v>MB040B</c:v>
                </c:pt>
                <c:pt idx="8">
                  <c:v>MB196B</c:v>
                </c:pt>
                <c:pt idx="9">
                  <c:v>MB032B</c:v>
                </c:pt>
                <c:pt idx="10">
                  <c:v>MB047B</c:v>
                </c:pt>
                <c:pt idx="11">
                  <c:v>MB316B</c:v>
                </c:pt>
                <c:pt idx="12">
                  <c:v>MB109B</c:v>
                </c:pt>
                <c:pt idx="13">
                  <c:v>MB213B</c:v>
                </c:pt>
                <c:pt idx="14">
                  <c:v>MB194B</c:v>
                </c:pt>
                <c:pt idx="15">
                  <c:v>MB087C</c:v>
                </c:pt>
                <c:pt idx="16">
                  <c:v>MB025B</c:v>
                </c:pt>
                <c:pt idx="17">
                  <c:v>MB301B</c:v>
                </c:pt>
              </c:strCache>
            </c:strRef>
          </c:cat>
          <c:val>
            <c:numRef>
              <c:f>Sheet1!$J$2:$J$19</c:f>
              <c:numCache>
                <c:formatCode>General</c:formatCode>
                <c:ptCount val="18"/>
                <c:pt idx="0">
                  <c:v>0.0194399242424242</c:v>
                </c:pt>
                <c:pt idx="1">
                  <c:v>0.0974043181818182</c:v>
                </c:pt>
                <c:pt idx="2">
                  <c:v>0.0124540350877193</c:v>
                </c:pt>
                <c:pt idx="3">
                  <c:v>0.106520277777778</c:v>
                </c:pt>
                <c:pt idx="4">
                  <c:v>0.0142105303030303</c:v>
                </c:pt>
                <c:pt idx="5">
                  <c:v>0.014694375</c:v>
                </c:pt>
                <c:pt idx="6">
                  <c:v>0.0595821739130435</c:v>
                </c:pt>
                <c:pt idx="7">
                  <c:v>0.0271441666666667</c:v>
                </c:pt>
                <c:pt idx="8">
                  <c:v>0.0338386111111111</c:v>
                </c:pt>
                <c:pt idx="9">
                  <c:v>0.0200991228070175</c:v>
                </c:pt>
                <c:pt idx="10">
                  <c:v>0.133216884057971</c:v>
                </c:pt>
                <c:pt idx="11">
                  <c:v>0.148182028985507</c:v>
                </c:pt>
                <c:pt idx="12">
                  <c:v>0.195167847222222</c:v>
                </c:pt>
                <c:pt idx="13">
                  <c:v>0.152710606060606</c:v>
                </c:pt>
                <c:pt idx="14">
                  <c:v>0.101103181818182</c:v>
                </c:pt>
                <c:pt idx="15">
                  <c:v>0.0521102222222222</c:v>
                </c:pt>
                <c:pt idx="16">
                  <c:v>0.119355694444444</c:v>
                </c:pt>
                <c:pt idx="17">
                  <c:v>0.253013402777778</c:v>
                </c:pt>
              </c:numCache>
            </c:numRef>
          </c:val>
        </c:ser>
        <c:ser>
          <c:idx val="2"/>
          <c:order val="2"/>
          <c:tx>
            <c:strRef>
              <c:f>Sheet1!$K$1</c:f>
              <c:strCache>
                <c:ptCount val="1"/>
                <c:pt idx="0">
                  <c:v>test</c:v>
                </c:pt>
              </c:strCache>
            </c:strRef>
          </c:tx>
          <c:spPr>
            <a:solidFill>
              <a:srgbClr val="FFFF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2:$O$19</c:f>
                <c:numCache>
                  <c:formatCode>General</c:formatCode>
                  <c:ptCount val="18"/>
                  <c:pt idx="0">
                    <c:v>0.063808242259701</c:v>
                  </c:pt>
                  <c:pt idx="1">
                    <c:v>0.0781849153285927</c:v>
                  </c:pt>
                  <c:pt idx="2">
                    <c:v>0.0679302325076696</c:v>
                  </c:pt>
                  <c:pt idx="3">
                    <c:v>0.0850906036552382</c:v>
                  </c:pt>
                  <c:pt idx="4">
                    <c:v>0.07628727473377</c:v>
                  </c:pt>
                  <c:pt idx="5">
                    <c:v>0.0581363707822274</c:v>
                  </c:pt>
                  <c:pt idx="6">
                    <c:v>0.0737245436835508</c:v>
                  </c:pt>
                  <c:pt idx="7">
                    <c:v>0.0688357817115879</c:v>
                  </c:pt>
                  <c:pt idx="8">
                    <c:v>0.0717577877217514</c:v>
                  </c:pt>
                  <c:pt idx="9">
                    <c:v>0.0538686701604752</c:v>
                  </c:pt>
                  <c:pt idx="10">
                    <c:v>0.0564069777547171</c:v>
                  </c:pt>
                  <c:pt idx="11">
                    <c:v>0.0904582139604386</c:v>
                  </c:pt>
                  <c:pt idx="12">
                    <c:v>0.0652766996706056</c:v>
                  </c:pt>
                  <c:pt idx="13">
                    <c:v>0.0746499987655545</c:v>
                  </c:pt>
                  <c:pt idx="14">
                    <c:v>0.058985416480091</c:v>
                  </c:pt>
                  <c:pt idx="15">
                    <c:v>0.0957952021820352</c:v>
                  </c:pt>
                  <c:pt idx="16">
                    <c:v>0.0445552336319945</c:v>
                  </c:pt>
                  <c:pt idx="17">
                    <c:v>0.06829012596779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H$2:$H$19</c:f>
              <c:strCache>
                <c:ptCount val="18"/>
                <c:pt idx="0">
                  <c:v>MB195B</c:v>
                </c:pt>
                <c:pt idx="1">
                  <c:v>MB312B</c:v>
                </c:pt>
                <c:pt idx="2">
                  <c:v>MB315C</c:v>
                </c:pt>
                <c:pt idx="3">
                  <c:v>MB299B</c:v>
                </c:pt>
                <c:pt idx="4">
                  <c:v>MB043B</c:v>
                </c:pt>
                <c:pt idx="5">
                  <c:v>MB188B</c:v>
                </c:pt>
                <c:pt idx="6">
                  <c:v>MB042B</c:v>
                </c:pt>
                <c:pt idx="7">
                  <c:v>MB040B</c:v>
                </c:pt>
                <c:pt idx="8">
                  <c:v>MB196B</c:v>
                </c:pt>
                <c:pt idx="9">
                  <c:v>MB032B</c:v>
                </c:pt>
                <c:pt idx="10">
                  <c:v>MB047B</c:v>
                </c:pt>
                <c:pt idx="11">
                  <c:v>MB316B</c:v>
                </c:pt>
                <c:pt idx="12">
                  <c:v>MB109B</c:v>
                </c:pt>
                <c:pt idx="13">
                  <c:v>MB213B</c:v>
                </c:pt>
                <c:pt idx="14">
                  <c:v>MB194B</c:v>
                </c:pt>
                <c:pt idx="15">
                  <c:v>MB087C</c:v>
                </c:pt>
                <c:pt idx="16">
                  <c:v>MB025B</c:v>
                </c:pt>
                <c:pt idx="17">
                  <c:v>MB301B</c:v>
                </c:pt>
              </c:strCache>
            </c:strRef>
          </c:cat>
          <c:val>
            <c:numRef>
              <c:f>Sheet1!$K$2:$K$19</c:f>
              <c:numCache>
                <c:formatCode>General</c:formatCode>
                <c:ptCount val="18"/>
                <c:pt idx="0">
                  <c:v>0.270495075757576</c:v>
                </c:pt>
                <c:pt idx="1">
                  <c:v>0.298619393939394</c:v>
                </c:pt>
                <c:pt idx="2">
                  <c:v>0.38359850877193</c:v>
                </c:pt>
                <c:pt idx="3">
                  <c:v>0.403469351851852</c:v>
                </c:pt>
                <c:pt idx="4">
                  <c:v>0.295787121212121</c:v>
                </c:pt>
                <c:pt idx="5">
                  <c:v>0.309922361111111</c:v>
                </c:pt>
                <c:pt idx="6">
                  <c:v>0.345789637681159</c:v>
                </c:pt>
                <c:pt idx="7">
                  <c:v>0.351331212121212</c:v>
                </c:pt>
                <c:pt idx="8">
                  <c:v>0.252465625</c:v>
                </c:pt>
                <c:pt idx="9">
                  <c:v>0.176231929824561</c:v>
                </c:pt>
                <c:pt idx="10">
                  <c:v>0.260685072463768</c:v>
                </c:pt>
                <c:pt idx="11">
                  <c:v>0.432055797101449</c:v>
                </c:pt>
                <c:pt idx="12">
                  <c:v>0.216859305555556</c:v>
                </c:pt>
                <c:pt idx="13">
                  <c:v>0.276962803030303</c:v>
                </c:pt>
                <c:pt idx="14">
                  <c:v>0.206654393939394</c:v>
                </c:pt>
                <c:pt idx="15">
                  <c:v>0.286167111111111</c:v>
                </c:pt>
                <c:pt idx="16">
                  <c:v>0.1588175</c:v>
                </c:pt>
                <c:pt idx="17">
                  <c:v>0.2338922222222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3423208"/>
        <c:axId val="-2115504120"/>
      </c:barChart>
      <c:catAx>
        <c:axId val="-21234232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15504120"/>
        <c:crosses val="autoZero"/>
        <c:auto val="1"/>
        <c:lblAlgn val="ctr"/>
        <c:lblOffset val="100"/>
        <c:noMultiLvlLbl val="0"/>
      </c:catAx>
      <c:valAx>
        <c:axId val="-2115504120"/>
        <c:scaling>
          <c:orientation val="minMax"/>
          <c:max val="0.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34232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4775546438861"/>
          <c:y val="0.0339760753928387"/>
          <c:w val="0.14444986999741"/>
          <c:h val="0.22473658642451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870629138308"/>
          <c:y val="0.0584372857491246"/>
          <c:w val="0.864113651070615"/>
          <c:h val="0.725882408324075"/>
        </c:manualLayout>
      </c:layout>
      <c:barChart>
        <c:barDir val="col"/>
        <c:grouping val="clustered"/>
        <c:varyColors val="0"/>
        <c:ser>
          <c:idx val="0"/>
          <c:order val="0"/>
          <c:tx>
            <c:v>train begin</c:v>
          </c:tx>
          <c:spPr>
            <a:solidFill>
              <a:srgbClr val="FF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K$61:$K$70</c:f>
                <c:numCache>
                  <c:formatCode>General</c:formatCode>
                  <c:ptCount val="10"/>
                  <c:pt idx="0">
                    <c:v>0.0648894829159642</c:v>
                  </c:pt>
                  <c:pt idx="1">
                    <c:v>0.066408977172896</c:v>
                  </c:pt>
                  <c:pt idx="2">
                    <c:v>0.0521599188192223</c:v>
                  </c:pt>
                  <c:pt idx="3">
                    <c:v>0.0652860607968204</c:v>
                  </c:pt>
                  <c:pt idx="4">
                    <c:v>0.0525922818860355</c:v>
                  </c:pt>
                  <c:pt idx="5">
                    <c:v>0.0604904613684272</c:v>
                  </c:pt>
                  <c:pt idx="6">
                    <c:v>0.0638424116834664</c:v>
                  </c:pt>
                  <c:pt idx="7">
                    <c:v>0.0580791989461113</c:v>
                  </c:pt>
                  <c:pt idx="8">
                    <c:v>0.0722385501353378</c:v>
                  </c:pt>
                  <c:pt idx="9">
                    <c:v>0.05852244222145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61:$F$70</c:f>
              <c:strCache>
                <c:ptCount val="10"/>
                <c:pt idx="0">
                  <c:v>MB060B</c:v>
                </c:pt>
                <c:pt idx="1">
                  <c:v>MB065B</c:v>
                </c:pt>
                <c:pt idx="2">
                  <c:v>MB504B</c:v>
                </c:pt>
                <c:pt idx="3">
                  <c:v>MB438B</c:v>
                </c:pt>
                <c:pt idx="4">
                  <c:v>MB439B</c:v>
                </c:pt>
                <c:pt idx="5">
                  <c:v>MB502B</c:v>
                </c:pt>
                <c:pt idx="6">
                  <c:v>MB308B</c:v>
                </c:pt>
                <c:pt idx="7">
                  <c:v>MB058B</c:v>
                </c:pt>
                <c:pt idx="8">
                  <c:v>MB296B</c:v>
                </c:pt>
                <c:pt idx="9">
                  <c:v>MB304B</c:v>
                </c:pt>
              </c:strCache>
            </c:strRef>
          </c:cat>
          <c:val>
            <c:numRef>
              <c:f>NewSort_20May15!$G$61:$G$70</c:f>
              <c:numCache>
                <c:formatCode>General</c:formatCode>
                <c:ptCount val="10"/>
                <c:pt idx="0">
                  <c:v>0.227819705882353</c:v>
                </c:pt>
                <c:pt idx="1">
                  <c:v>0.26489125</c:v>
                </c:pt>
                <c:pt idx="2">
                  <c:v>0.161653484848485</c:v>
                </c:pt>
                <c:pt idx="3">
                  <c:v>0.292998684210526</c:v>
                </c:pt>
                <c:pt idx="4">
                  <c:v>0.25963373015873</c:v>
                </c:pt>
                <c:pt idx="5">
                  <c:v>0.379458194444444</c:v>
                </c:pt>
                <c:pt idx="6">
                  <c:v>0.373737173913044</c:v>
                </c:pt>
                <c:pt idx="7">
                  <c:v>0.373192898550725</c:v>
                </c:pt>
                <c:pt idx="8">
                  <c:v>0.409700714285714</c:v>
                </c:pt>
                <c:pt idx="9">
                  <c:v>0.289352424242424</c:v>
                </c:pt>
              </c:numCache>
            </c:numRef>
          </c:val>
        </c:ser>
        <c:ser>
          <c:idx val="1"/>
          <c:order val="1"/>
          <c:tx>
            <c:v>train end</c:v>
          </c:tx>
          <c:spPr>
            <a:solidFill>
              <a:srgbClr val="0000FF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L$61:$L$70</c:f>
                <c:numCache>
                  <c:formatCode>General</c:formatCode>
                  <c:ptCount val="10"/>
                  <c:pt idx="0">
                    <c:v>0.0158450738211694</c:v>
                  </c:pt>
                  <c:pt idx="1">
                    <c:v>0.0334517585528222</c:v>
                  </c:pt>
                  <c:pt idx="2">
                    <c:v>0.0252284573750858</c:v>
                  </c:pt>
                  <c:pt idx="3">
                    <c:v>0.0559749255266819</c:v>
                  </c:pt>
                  <c:pt idx="4">
                    <c:v>0.039392239854238</c:v>
                  </c:pt>
                  <c:pt idx="5">
                    <c:v>0.0529784433283685</c:v>
                  </c:pt>
                  <c:pt idx="6">
                    <c:v>0.0278478674699547</c:v>
                  </c:pt>
                  <c:pt idx="7">
                    <c:v>0.0371344641517479</c:v>
                  </c:pt>
                  <c:pt idx="8">
                    <c:v>0.0378472406484217</c:v>
                  </c:pt>
                  <c:pt idx="9">
                    <c:v>0.03251007274554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61:$F$70</c:f>
              <c:strCache>
                <c:ptCount val="10"/>
                <c:pt idx="0">
                  <c:v>MB060B</c:v>
                </c:pt>
                <c:pt idx="1">
                  <c:v>MB065B</c:v>
                </c:pt>
                <c:pt idx="2">
                  <c:v>MB504B</c:v>
                </c:pt>
                <c:pt idx="3">
                  <c:v>MB438B</c:v>
                </c:pt>
                <c:pt idx="4">
                  <c:v>MB439B</c:v>
                </c:pt>
                <c:pt idx="5">
                  <c:v>MB502B</c:v>
                </c:pt>
                <c:pt idx="6">
                  <c:v>MB308B</c:v>
                </c:pt>
                <c:pt idx="7">
                  <c:v>MB058B</c:v>
                </c:pt>
                <c:pt idx="8">
                  <c:v>MB296B</c:v>
                </c:pt>
                <c:pt idx="9">
                  <c:v>MB304B</c:v>
                </c:pt>
              </c:strCache>
            </c:strRef>
          </c:cat>
          <c:val>
            <c:numRef>
              <c:f>NewSort_20May15!$H$61:$H$70</c:f>
              <c:numCache>
                <c:formatCode>General</c:formatCode>
                <c:ptCount val="10"/>
                <c:pt idx="0">
                  <c:v>0.0304110784313725</c:v>
                </c:pt>
                <c:pt idx="1">
                  <c:v>0.0548881666666667</c:v>
                </c:pt>
                <c:pt idx="2">
                  <c:v>0.0689872727272727</c:v>
                </c:pt>
                <c:pt idx="3">
                  <c:v>0.244976842105263</c:v>
                </c:pt>
                <c:pt idx="4">
                  <c:v>0.197822698412698</c:v>
                </c:pt>
                <c:pt idx="5">
                  <c:v>0.158999861111111</c:v>
                </c:pt>
                <c:pt idx="6">
                  <c:v>0.0632589130434782</c:v>
                </c:pt>
                <c:pt idx="7">
                  <c:v>0.0787605072463768</c:v>
                </c:pt>
                <c:pt idx="8">
                  <c:v>0.0764380952380952</c:v>
                </c:pt>
                <c:pt idx="9">
                  <c:v>0.0963337878787878</c:v>
                </c:pt>
              </c:numCache>
            </c:numRef>
          </c:val>
        </c:ser>
        <c:ser>
          <c:idx val="2"/>
          <c:order val="2"/>
          <c:tx>
            <c:v>test</c:v>
          </c:tx>
          <c:spPr>
            <a:solidFill>
              <a:srgbClr val="FFFF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NewSort_20May15!$M$61:$M$70</c:f>
                <c:numCache>
                  <c:formatCode>General</c:formatCode>
                  <c:ptCount val="10"/>
                  <c:pt idx="0">
                    <c:v>0.0837967580221747</c:v>
                  </c:pt>
                  <c:pt idx="1">
                    <c:v>0.0791338415459726</c:v>
                  </c:pt>
                  <c:pt idx="2">
                    <c:v>0.0666202545495913</c:v>
                  </c:pt>
                  <c:pt idx="3">
                    <c:v>0.0738014208354832</c:v>
                  </c:pt>
                  <c:pt idx="4">
                    <c:v>0.0543571486206881</c:v>
                  </c:pt>
                  <c:pt idx="5">
                    <c:v>0.06884823211783</c:v>
                  </c:pt>
                  <c:pt idx="6">
                    <c:v>0.0693954942685654</c:v>
                  </c:pt>
                  <c:pt idx="7">
                    <c:v>0.0697609136688875</c:v>
                  </c:pt>
                  <c:pt idx="8">
                    <c:v>0.0840656539549087</c:v>
                  </c:pt>
                  <c:pt idx="9">
                    <c:v>0.05407040617226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NewSort_20May15!$F$61:$F$70</c:f>
              <c:strCache>
                <c:ptCount val="10"/>
                <c:pt idx="0">
                  <c:v>MB060B</c:v>
                </c:pt>
                <c:pt idx="1">
                  <c:v>MB065B</c:v>
                </c:pt>
                <c:pt idx="2">
                  <c:v>MB504B</c:v>
                </c:pt>
                <c:pt idx="3">
                  <c:v>MB438B</c:v>
                </c:pt>
                <c:pt idx="4">
                  <c:v>MB439B</c:v>
                </c:pt>
                <c:pt idx="5">
                  <c:v>MB502B</c:v>
                </c:pt>
                <c:pt idx="6">
                  <c:v>MB308B</c:v>
                </c:pt>
                <c:pt idx="7">
                  <c:v>MB058B</c:v>
                </c:pt>
                <c:pt idx="8">
                  <c:v>MB296B</c:v>
                </c:pt>
                <c:pt idx="9">
                  <c:v>MB304B</c:v>
                </c:pt>
              </c:strCache>
            </c:strRef>
          </c:cat>
          <c:val>
            <c:numRef>
              <c:f>NewSort_20May15!$I$61:$I$70</c:f>
              <c:numCache>
                <c:formatCode>General</c:formatCode>
                <c:ptCount val="10"/>
                <c:pt idx="0">
                  <c:v>0.224374117647059</c:v>
                </c:pt>
                <c:pt idx="1">
                  <c:v>0.264886166666667</c:v>
                </c:pt>
                <c:pt idx="2">
                  <c:v>0.328919393939394</c:v>
                </c:pt>
                <c:pt idx="3">
                  <c:v>0.355625614035088</c:v>
                </c:pt>
                <c:pt idx="4">
                  <c:v>0.0992392857142857</c:v>
                </c:pt>
                <c:pt idx="5">
                  <c:v>0.308090347222222</c:v>
                </c:pt>
                <c:pt idx="6">
                  <c:v>0.259857391304348</c:v>
                </c:pt>
                <c:pt idx="7">
                  <c:v>0.268281086956522</c:v>
                </c:pt>
                <c:pt idx="8">
                  <c:v>0.299618492063492</c:v>
                </c:pt>
                <c:pt idx="9">
                  <c:v>0.1915128030303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6760872"/>
        <c:axId val="-2100646040"/>
      </c:barChart>
      <c:catAx>
        <c:axId val="-208676087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-2100646040"/>
        <c:crosses val="autoZero"/>
        <c:auto val="1"/>
        <c:lblAlgn val="ctr"/>
        <c:lblOffset val="100"/>
        <c:noMultiLvlLbl val="0"/>
      </c:catAx>
      <c:valAx>
        <c:axId val="-2100646040"/>
        <c:scaling>
          <c:orientation val="minMax"/>
          <c:max val="0.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urtship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0867608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1800756017518"/>
          <c:y val="0.0499233519428893"/>
          <c:w val="0.14442603190469"/>
          <c:h val="0.27082868035441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40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1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2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33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31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7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98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06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63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BE928-216F-DE44-BE2E-D1211575672C}" type="datetimeFigureOut">
              <a:rPr lang="en-US" smtClean="0"/>
              <a:t>9/2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5EBD2-CDDD-4E43-AF91-49821E0AA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459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7" name="Chart 1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7756266"/>
              </p:ext>
            </p:extLst>
          </p:nvPr>
        </p:nvGraphicFramePr>
        <p:xfrm>
          <a:off x="760393" y="3354996"/>
          <a:ext cx="5537775" cy="27502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7" name="Chart 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6051203"/>
              </p:ext>
            </p:extLst>
          </p:nvPr>
        </p:nvGraphicFramePr>
        <p:xfrm>
          <a:off x="751790" y="483970"/>
          <a:ext cx="5537582" cy="2783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01275" y="104976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ure S7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04095" y="3579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04095" y="3231642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B</a:t>
            </a:r>
          </a:p>
        </p:txBody>
      </p:sp>
      <p:sp>
        <p:nvSpPr>
          <p:cNvPr id="7" name="Right Bracket 6"/>
          <p:cNvSpPr/>
          <p:nvPr/>
        </p:nvSpPr>
        <p:spPr>
          <a:xfrm>
            <a:off x="1499833" y="187896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09125" y="148444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612425" y="187319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1" name="Right Bracket 10"/>
          <p:cNvSpPr/>
          <p:nvPr/>
        </p:nvSpPr>
        <p:spPr>
          <a:xfrm>
            <a:off x="1511440" y="4397164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74774" y="430076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3" name="Right Bracket 12"/>
          <p:cNvSpPr/>
          <p:nvPr/>
        </p:nvSpPr>
        <p:spPr>
          <a:xfrm>
            <a:off x="1550047" y="1602585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4" name="Right Bracket 13"/>
          <p:cNvSpPr/>
          <p:nvPr/>
        </p:nvSpPr>
        <p:spPr>
          <a:xfrm>
            <a:off x="1753347" y="1990529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5" name="Right Bracket 14"/>
          <p:cNvSpPr/>
          <p:nvPr/>
        </p:nvSpPr>
        <p:spPr>
          <a:xfrm>
            <a:off x="1823863" y="1485561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6" name="Right Bracket 15"/>
          <p:cNvSpPr/>
          <p:nvPr/>
        </p:nvSpPr>
        <p:spPr>
          <a:xfrm>
            <a:off x="2023361" y="186552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7" name="Right Bracket 16"/>
          <p:cNvSpPr/>
          <p:nvPr/>
        </p:nvSpPr>
        <p:spPr>
          <a:xfrm>
            <a:off x="2078947" y="1266846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8" name="Right Bracket 17"/>
          <p:cNvSpPr/>
          <p:nvPr/>
        </p:nvSpPr>
        <p:spPr>
          <a:xfrm>
            <a:off x="2290735" y="1546106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9" name="Right Bracket 18"/>
          <p:cNvSpPr/>
          <p:nvPr/>
        </p:nvSpPr>
        <p:spPr>
          <a:xfrm>
            <a:off x="2348775" y="1165616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0" name="Right Bracket 19"/>
          <p:cNvSpPr/>
          <p:nvPr/>
        </p:nvSpPr>
        <p:spPr>
          <a:xfrm>
            <a:off x="2611672" y="1489735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1" name="Right Bracket 20"/>
          <p:cNvSpPr/>
          <p:nvPr/>
        </p:nvSpPr>
        <p:spPr>
          <a:xfrm>
            <a:off x="2819623" y="1632581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2" name="Right Bracket 21"/>
          <p:cNvSpPr/>
          <p:nvPr/>
        </p:nvSpPr>
        <p:spPr>
          <a:xfrm>
            <a:off x="3086034" y="1228094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3" name="Right Bracket 22"/>
          <p:cNvSpPr/>
          <p:nvPr/>
        </p:nvSpPr>
        <p:spPr>
          <a:xfrm>
            <a:off x="2869469" y="1503069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4" name="Right Bracket 23"/>
          <p:cNvSpPr/>
          <p:nvPr/>
        </p:nvSpPr>
        <p:spPr>
          <a:xfrm>
            <a:off x="3346729" y="171455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5" name="Right Bracket 24"/>
          <p:cNvSpPr/>
          <p:nvPr/>
        </p:nvSpPr>
        <p:spPr>
          <a:xfrm>
            <a:off x="3135522" y="1351685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6" name="Right Bracket 25"/>
          <p:cNvSpPr/>
          <p:nvPr/>
        </p:nvSpPr>
        <p:spPr>
          <a:xfrm>
            <a:off x="3391945" y="1361721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7" name="Right Bracket 26"/>
          <p:cNvSpPr/>
          <p:nvPr/>
        </p:nvSpPr>
        <p:spPr>
          <a:xfrm>
            <a:off x="3609809" y="1492439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8" name="Right Bracket 27"/>
          <p:cNvSpPr/>
          <p:nvPr/>
        </p:nvSpPr>
        <p:spPr>
          <a:xfrm>
            <a:off x="3660960" y="1642403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29" name="Right Bracket 28"/>
          <p:cNvSpPr/>
          <p:nvPr/>
        </p:nvSpPr>
        <p:spPr>
          <a:xfrm>
            <a:off x="3874246" y="1787696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0" name="Right Bracket 29"/>
          <p:cNvSpPr/>
          <p:nvPr/>
        </p:nvSpPr>
        <p:spPr>
          <a:xfrm>
            <a:off x="3927417" y="1900563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1" name="Right Bracket 30"/>
          <p:cNvSpPr/>
          <p:nvPr/>
        </p:nvSpPr>
        <p:spPr>
          <a:xfrm>
            <a:off x="4404170" y="1684336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2" name="Right Bracket 31"/>
          <p:cNvSpPr/>
          <p:nvPr/>
        </p:nvSpPr>
        <p:spPr>
          <a:xfrm>
            <a:off x="4668365" y="121491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3" name="Right Bracket 32"/>
          <p:cNvSpPr/>
          <p:nvPr/>
        </p:nvSpPr>
        <p:spPr>
          <a:xfrm>
            <a:off x="4928367" y="133257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4" name="Right Bracket 33"/>
          <p:cNvSpPr/>
          <p:nvPr/>
        </p:nvSpPr>
        <p:spPr>
          <a:xfrm>
            <a:off x="5189525" y="117341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5" name="Right Bracket 34"/>
          <p:cNvSpPr/>
          <p:nvPr/>
        </p:nvSpPr>
        <p:spPr>
          <a:xfrm>
            <a:off x="5454326" y="1486980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7" name="Right Bracket 36"/>
          <p:cNvSpPr/>
          <p:nvPr/>
        </p:nvSpPr>
        <p:spPr>
          <a:xfrm>
            <a:off x="5714617" y="1042904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8" name="Right Bracket 37"/>
          <p:cNvSpPr/>
          <p:nvPr/>
        </p:nvSpPr>
        <p:spPr>
          <a:xfrm>
            <a:off x="5983589" y="1163572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357985" y="175944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681680" y="136689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882622" y="174608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148865" y="142709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208085" y="105446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469124" y="136808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667832" y="1524556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944925" y="111028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0795" y="138212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204702" y="159498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990512" y="1246613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252343" y="123737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470396" y="136753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522286" y="152449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731252" y="1675248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790655" y="178136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263976" y="157083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525597" y="109837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785373" y="121713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048990" y="105290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314380" y="137131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575316" y="92352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842294" y="1046530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495772" y="443724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444211" y="399204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512693" y="441815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641579" y="437749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5143538" y="467014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252779" y="4500725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672383" y="4705372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785493" y="426667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545169" y="979752"/>
            <a:ext cx="44249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467766" y="3446239"/>
            <a:ext cx="11440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467766" y="3689589"/>
            <a:ext cx="11440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467766" y="3940299"/>
            <a:ext cx="48045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915903" y="3877846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536694" y="772766"/>
            <a:ext cx="58675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544772" y="560140"/>
            <a:ext cx="6046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940353" y="114733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88" name="Right Bracket 87"/>
          <p:cNvSpPr/>
          <p:nvPr/>
        </p:nvSpPr>
        <p:spPr>
          <a:xfrm>
            <a:off x="2555638" y="2040840"/>
            <a:ext cx="36576" cy="64008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410628" y="191920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979999" y="441960"/>
            <a:ext cx="9173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AM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580865" y="3289668"/>
            <a:ext cx="16979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AM Secondary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94302" y="594128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C</a:t>
            </a:r>
          </a:p>
        </p:txBody>
      </p:sp>
      <p:grpSp>
        <p:nvGrpSpPr>
          <p:cNvPr id="93" name="Group 92"/>
          <p:cNvGrpSpPr/>
          <p:nvPr/>
        </p:nvGrpSpPr>
        <p:grpSpPr>
          <a:xfrm>
            <a:off x="638190" y="6025242"/>
            <a:ext cx="5538496" cy="2825251"/>
            <a:chOff x="677583" y="463985"/>
            <a:chExt cx="5538496" cy="2825251"/>
          </a:xfrm>
        </p:grpSpPr>
        <p:graphicFrame>
          <p:nvGraphicFramePr>
            <p:cNvPr id="94" name="Chart 9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98674768"/>
                </p:ext>
              </p:extLst>
            </p:nvPr>
          </p:nvGraphicFramePr>
          <p:xfrm>
            <a:off x="677583" y="463985"/>
            <a:ext cx="5538496" cy="28252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5" name="Right Bracket 94"/>
            <p:cNvSpPr/>
            <p:nvPr/>
          </p:nvSpPr>
          <p:spPr>
            <a:xfrm>
              <a:off x="1500880" y="1687835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366507" y="1591736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97" name="Right Bracket 96"/>
            <p:cNvSpPr/>
            <p:nvPr/>
          </p:nvSpPr>
          <p:spPr>
            <a:xfrm>
              <a:off x="1979650" y="1579095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98" name="Right Bracket 97"/>
            <p:cNvSpPr/>
            <p:nvPr/>
          </p:nvSpPr>
          <p:spPr>
            <a:xfrm>
              <a:off x="2458420" y="1921415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99" name="Right Bracket 98"/>
            <p:cNvSpPr/>
            <p:nvPr/>
          </p:nvSpPr>
          <p:spPr>
            <a:xfrm>
              <a:off x="2559298" y="1387265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0" name="Right Bracket 99"/>
            <p:cNvSpPr/>
            <p:nvPr/>
          </p:nvSpPr>
          <p:spPr>
            <a:xfrm>
              <a:off x="3898560" y="1257006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1" name="Right Bracket 100"/>
            <p:cNvSpPr/>
            <p:nvPr/>
          </p:nvSpPr>
          <p:spPr>
            <a:xfrm>
              <a:off x="4371396" y="1261031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2" name="Right Bracket 101"/>
            <p:cNvSpPr/>
            <p:nvPr/>
          </p:nvSpPr>
          <p:spPr>
            <a:xfrm>
              <a:off x="4850166" y="1276926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3" name="Right Bracket 102"/>
            <p:cNvSpPr/>
            <p:nvPr/>
          </p:nvSpPr>
          <p:spPr>
            <a:xfrm>
              <a:off x="5328936" y="1126641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4" name="Right Bracket 103"/>
            <p:cNvSpPr/>
            <p:nvPr/>
          </p:nvSpPr>
          <p:spPr>
            <a:xfrm>
              <a:off x="5807706" y="1534246"/>
              <a:ext cx="45719" cy="100584"/>
            </a:xfrm>
            <a:prstGeom prst="rightBracket">
              <a:avLst/>
            </a:prstGeom>
            <a:noFill/>
            <a:ln w="12700">
              <a:solidFill>
                <a:schemeClr val="tx1"/>
              </a:solidFill>
            </a:ln>
            <a:effectLst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839343" y="1482996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324047" y="1825316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420744" y="1294052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760006" y="1157005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232842" y="116103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711612" y="1176925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5190382" y="102664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*</a:t>
              </a:r>
              <a:endParaRPr lang="en-US" sz="500" dirty="0">
                <a:latin typeface="Arial"/>
                <a:cs typeface="Arial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669152" y="1440180"/>
              <a:ext cx="324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 smtClean="0">
                  <a:latin typeface="Arial"/>
                  <a:cs typeface="Arial"/>
                </a:rPr>
                <a:t>**</a:t>
              </a:r>
              <a:endParaRPr lang="en-US" sz="500" dirty="0">
                <a:latin typeface="Arial"/>
                <a:cs typeface="Arial"/>
              </a:endParaRPr>
            </a:p>
          </p:txBody>
        </p:sp>
      </p:grpSp>
      <p:sp>
        <p:nvSpPr>
          <p:cNvPr id="113" name="TextBox 112"/>
          <p:cNvSpPr txBox="1"/>
          <p:nvPr/>
        </p:nvSpPr>
        <p:spPr>
          <a:xfrm>
            <a:off x="1456656" y="6150665"/>
            <a:ext cx="6046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begin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456657" y="6409891"/>
            <a:ext cx="6046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end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456657" y="6666546"/>
            <a:ext cx="60467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CI</a:t>
            </a:r>
            <a:r>
              <a:rPr lang="en-US" sz="1000" baseline="-25000" dirty="0" smtClean="0">
                <a:latin typeface="Arial"/>
                <a:cs typeface="Arial"/>
              </a:rPr>
              <a:t>test</a:t>
            </a:r>
            <a:endParaRPr lang="en-US" sz="1000" baseline="-25000" dirty="0">
              <a:latin typeface="Arial"/>
              <a:cs typeface="Arial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2946702" y="6105285"/>
            <a:ext cx="9717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Arial"/>
                <a:cs typeface="Arial"/>
              </a:rPr>
              <a:t>PPL1 Lines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18" name="Right Bracket 117"/>
          <p:cNvSpPr/>
          <p:nvPr/>
        </p:nvSpPr>
        <p:spPr>
          <a:xfrm>
            <a:off x="1632288" y="4533788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19" name="Right Bracket 118"/>
          <p:cNvSpPr/>
          <p:nvPr/>
        </p:nvSpPr>
        <p:spPr>
          <a:xfrm>
            <a:off x="2052880" y="3984156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0" name="Right Bracket 119"/>
          <p:cNvSpPr/>
          <p:nvPr/>
        </p:nvSpPr>
        <p:spPr>
          <a:xfrm>
            <a:off x="2583904" y="4089228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1" name="Right Bracket 120"/>
          <p:cNvSpPr/>
          <p:nvPr/>
        </p:nvSpPr>
        <p:spPr>
          <a:xfrm>
            <a:off x="2704752" y="3650028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565059" y="3552844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23" name="Right Bracket 122"/>
          <p:cNvSpPr/>
          <p:nvPr/>
        </p:nvSpPr>
        <p:spPr>
          <a:xfrm>
            <a:off x="3651312" y="4525596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4" name="Right Bracket 123"/>
          <p:cNvSpPr/>
          <p:nvPr/>
        </p:nvSpPr>
        <p:spPr>
          <a:xfrm>
            <a:off x="3780048" y="4480796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5" name="Right Bracket 124"/>
          <p:cNvSpPr/>
          <p:nvPr/>
        </p:nvSpPr>
        <p:spPr>
          <a:xfrm>
            <a:off x="4737024" y="4207244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6" name="Right Bracket 125"/>
          <p:cNvSpPr/>
          <p:nvPr/>
        </p:nvSpPr>
        <p:spPr>
          <a:xfrm>
            <a:off x="4865760" y="3665500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7" name="Right Bracket 126"/>
          <p:cNvSpPr/>
          <p:nvPr/>
        </p:nvSpPr>
        <p:spPr>
          <a:xfrm>
            <a:off x="5278464" y="4780236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8" name="Right Bracket 127"/>
          <p:cNvSpPr/>
          <p:nvPr/>
        </p:nvSpPr>
        <p:spPr>
          <a:xfrm>
            <a:off x="5391424" y="4601340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29" name="Right Bracket 128"/>
          <p:cNvSpPr/>
          <p:nvPr/>
        </p:nvSpPr>
        <p:spPr>
          <a:xfrm>
            <a:off x="5812016" y="4801068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30" name="Right Bracket 129"/>
          <p:cNvSpPr/>
          <p:nvPr/>
        </p:nvSpPr>
        <p:spPr>
          <a:xfrm>
            <a:off x="5924976" y="4369756"/>
            <a:ext cx="45719" cy="94389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  <a:effectLst/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598398" y="4109769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4727134" y="3560137"/>
            <a:ext cx="3245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 smtClean="0">
                <a:latin typeface="Arial"/>
                <a:cs typeface="Arial"/>
              </a:rPr>
              <a:t>****</a:t>
            </a:r>
            <a:endParaRPr lang="en-US" sz="5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72884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3</Words>
  <Application>Microsoft Macintosh PowerPoint</Application>
  <PresentationFormat>Letter Paper (8.5x11 in)</PresentationFormat>
  <Paragraphs>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by Montague</dc:creator>
  <cp:lastModifiedBy>Shelby Montague</cp:lastModifiedBy>
  <cp:revision>6</cp:revision>
  <dcterms:created xsi:type="dcterms:W3CDTF">2016-09-29T23:23:19Z</dcterms:created>
  <dcterms:modified xsi:type="dcterms:W3CDTF">2016-09-29T23:25:19Z</dcterms:modified>
</cp:coreProperties>
</file>